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90" autoAdjust="0"/>
    <p:restoredTop sz="94660"/>
  </p:normalViewPr>
  <p:slideViewPr>
    <p:cSldViewPr snapToGrid="0">
      <p:cViewPr varScale="1">
        <p:scale>
          <a:sx n="157" d="100"/>
          <a:sy n="157" d="100"/>
        </p:scale>
        <p:origin x="156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FB2379-216D-2B01-D2CD-D35016F8D7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27FEC2-B30C-E985-A3EA-7E539A2569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56A7AD-ABA2-6135-E5D5-FADA2913D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4E4971-E5AB-4481-CBA4-658DF1A80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13F7B6-ED9B-FD7E-559D-A5E3136FD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063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CA1CD-2103-1A62-8EE4-14E5DB02F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22DB5C-2E20-C3FA-1118-ABE451B779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4692FA-902E-BCD9-7A18-826AA615D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732C4E-136E-39D7-A2FB-F74F1288F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E3EC69-FE95-2BD2-F1AF-585C86C70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499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19EA68F-864A-ADE7-134E-7F3C8D05E5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4EB1F-411C-05A1-6221-509F105A1F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6954EF-48F6-24CB-164A-3656583F8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684B14-1ADA-24CE-8E96-DB470836B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E685D2-1EA1-AB23-FC27-612D93830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26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910035-4DA7-642A-5E6A-EBEF42BF7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A1A093-19B3-2C49-3B33-965E75ED2C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EB958D-0624-C122-62F3-8986D93EF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2D4D7A-694A-3F37-B5C5-ECABC7905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D8201C-CFAA-718D-B080-19FFB9927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351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B9BC8D-DEE4-64FE-D47E-8C17997DB7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37563F-A04B-22B3-A362-2AACCD28B4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C4B680-4F58-FE92-5590-E36222E9B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211226-C07D-16F1-EAF6-72CB3CA1A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AFFB93-7683-BDB3-C39C-534861976E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277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F7D76E-D2E7-C4F2-5251-AE1F4E8D45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77CE61-7F34-AF6D-0401-40C1880354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C32F82-F0BF-3BDF-EBBC-3410F132B5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F9527A-91DE-BB08-5C22-D0DB8A681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3BA8C8-1CB8-1DA0-F515-2DE4017B2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036C4B-7229-21E4-377A-5CF27FCEC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540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B48053-D0E3-ABB5-4832-4443C2716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E42156-87AD-C055-EB19-A27A3A0AB6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E3B08D-C599-331A-6A01-E64A372BD6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8B7997A-699E-1AF4-8B52-B4926E2F4A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B05F1F-04B8-A496-1AFB-C89B73F065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518AEE-1CA6-43B9-9155-DF9701975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A51233A-7819-3FC9-CDF8-36C550B1B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1E3395-C9BB-7737-C39A-073EB24E8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799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FCBEF2-6165-AEA2-CD6B-BD536619F6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4C1985-8736-156C-EDAE-843606C0A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5B980E-D9AF-9B6F-8C28-CC7E677DF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F6022E-B0E5-BFE4-9E25-60989B683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088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4754E22-7A5F-EBDF-76FD-749926590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5D44EB-FBF7-7BF3-F8A4-E4343FE96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1D2EE0-7C45-5B4E-30C5-557BBDA82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109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C6D60-39B0-95BF-9CAD-D42C51DEA3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D72C9A-6100-221D-0D9E-C3B963D636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881F9F-9D33-025D-DBEF-729F1BAB3F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45F3EC-D5F4-5879-1F2B-1A3552C66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569C66-0762-DB74-33CC-16AAE2374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0CADA5-2AEC-2D26-78B3-8C732831E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763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C6A4F-0FAB-9D03-54DC-852C986234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785886-5A76-E780-1033-9A7F085812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5472B9-DF8D-4A6F-B1FE-792A9D5F63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05566C-D987-D14B-D896-32388695D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234AB0-1967-B24B-64C3-CB8BD5EE6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BE8F3E-DC98-382E-BE8C-21D473FEF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929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AEBDE2-8E05-E1B2-6B86-D5F6059673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BF9E2C-3D99-9F1D-5B5E-FFD781E19A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5C1199-9C6D-E066-7DB6-6A39D053E5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42EEB6-AFFF-4169-B37A-B4D52C3C5057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513A06-C0F6-4F3F-A5A7-4CAD15C6E1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289EE-A770-556B-3F72-59FF7DEA9F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77931A0-D0D9-40A9-B839-C99F9C864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905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4734E4D-3BDB-63E7-DBE8-87CF983FE3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4839" y="34978"/>
            <a:ext cx="4888905" cy="339402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CA8BEFF-5D8F-D968-65A2-FAD226C999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51290" y="34977"/>
            <a:ext cx="5263433" cy="3429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353EA1C-A7EC-87D7-BCEA-522AA3BFC0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60811" y="3394023"/>
            <a:ext cx="4898280" cy="34639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7E6EA59-93E8-2100-2EF5-91006BF56FF0}"/>
              </a:ext>
            </a:extLst>
          </p:cNvPr>
          <p:cNvSpPr txBox="1"/>
          <p:nvPr/>
        </p:nvSpPr>
        <p:spPr>
          <a:xfrm>
            <a:off x="1093461" y="349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58B487F-86A1-C39D-9576-FBC859F54F42}"/>
              </a:ext>
            </a:extLst>
          </p:cNvPr>
          <p:cNvSpPr txBox="1"/>
          <p:nvPr/>
        </p:nvSpPr>
        <p:spPr>
          <a:xfrm>
            <a:off x="6509433" y="349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0EC4BD9-A984-D967-D96B-1A9333EEA1C8}"/>
              </a:ext>
            </a:extLst>
          </p:cNvPr>
          <p:cNvSpPr txBox="1"/>
          <p:nvPr/>
        </p:nvSpPr>
        <p:spPr>
          <a:xfrm>
            <a:off x="6509433" y="33940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8A99FC79-F589-E641-B2EB-B4318007B0D8}"/>
              </a:ext>
            </a:extLst>
          </p:cNvPr>
          <p:cNvSpPr txBox="1"/>
          <p:nvPr/>
        </p:nvSpPr>
        <p:spPr>
          <a:xfrm>
            <a:off x="219457" y="5004817"/>
            <a:ext cx="6114288" cy="1318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upplementary Fig. 3</a:t>
            </a:r>
            <a:r>
              <a:rPr lang="en-US" sz="14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Scatterplot demonstrating temporal evolution of sEMG burst duration (A), frequency (B) and amplitude (C) for a clonic seizure with clear EEG correlate for patient #1 (same seizure as shown in Fig. 5B). </a:t>
            </a:r>
          </a:p>
        </p:txBody>
      </p:sp>
    </p:spTree>
    <p:extLst>
      <p:ext uri="{BB962C8B-B14F-4D97-AF65-F5344CB8AC3E}">
        <p14:creationId xmlns:p14="http://schemas.microsoft.com/office/powerpoint/2010/main" val="1621554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mbria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otedar, Neel</dc:creator>
  <cp:lastModifiedBy>Fotedar, Neel</cp:lastModifiedBy>
  <cp:revision>4</cp:revision>
  <dcterms:created xsi:type="dcterms:W3CDTF">2025-04-15T16:51:01Z</dcterms:created>
  <dcterms:modified xsi:type="dcterms:W3CDTF">2025-05-06T17:55:22Z</dcterms:modified>
</cp:coreProperties>
</file>